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D62B88F-7099-4CD7-9F14-A4249C421CC5}" v="19" dt="2025-03-17T17:27:49.75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33"/>
  </p:normalViewPr>
  <p:slideViewPr>
    <p:cSldViewPr snapToGrid="0">
      <p:cViewPr varScale="1">
        <p:scale>
          <a:sx n="106" d="100"/>
          <a:sy n="106" d="100"/>
        </p:scale>
        <p:origin x="7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ynak, Ahmet (kaynakat)" userId="e30822f5-f881-493f-bf88-3d523b0e27a6" providerId="ADAL" clId="{9D62B88F-7099-4CD7-9F14-A4249C421CC5}"/>
    <pc:docChg chg="undo redo custSel addSld modSld sldOrd">
      <pc:chgData name="Kaynak, Ahmet (kaynakat)" userId="e30822f5-f881-493f-bf88-3d523b0e27a6" providerId="ADAL" clId="{9D62B88F-7099-4CD7-9F14-A4249C421CC5}" dt="2025-03-17T17:36:31.795" v="219" actId="1076"/>
      <pc:docMkLst>
        <pc:docMk/>
      </pc:docMkLst>
      <pc:sldChg chg="modSp mod">
        <pc:chgData name="Kaynak, Ahmet (kaynakat)" userId="e30822f5-f881-493f-bf88-3d523b0e27a6" providerId="ADAL" clId="{9D62B88F-7099-4CD7-9F14-A4249C421CC5}" dt="2025-03-14T20:23:15.470" v="167" actId="20577"/>
        <pc:sldMkLst>
          <pc:docMk/>
          <pc:sldMk cId="2110851604" sldId="258"/>
        </pc:sldMkLst>
        <pc:spChg chg="mod">
          <ac:chgData name="Kaynak, Ahmet (kaynakat)" userId="e30822f5-f881-493f-bf88-3d523b0e27a6" providerId="ADAL" clId="{9D62B88F-7099-4CD7-9F14-A4249C421CC5}" dt="2025-03-14T20:23:15.470" v="167" actId="20577"/>
          <ac:spMkLst>
            <pc:docMk/>
            <pc:sldMk cId="2110851604" sldId="258"/>
            <ac:spMk id="3" creationId="{7422526D-8CE4-2DAB-7C5F-A4BAEF10F5DD}"/>
          </ac:spMkLst>
        </pc:spChg>
      </pc:sldChg>
      <pc:sldChg chg="addSp delSp modSp add mod ord">
        <pc:chgData name="Kaynak, Ahmet (kaynakat)" userId="e30822f5-f881-493f-bf88-3d523b0e27a6" providerId="ADAL" clId="{9D62B88F-7099-4CD7-9F14-A4249C421CC5}" dt="2025-03-17T17:36:31.795" v="219" actId="1076"/>
        <pc:sldMkLst>
          <pc:docMk/>
          <pc:sldMk cId="1435814156" sldId="259"/>
        </pc:sldMkLst>
        <pc:spChg chg="mod">
          <ac:chgData name="Kaynak, Ahmet (kaynakat)" userId="e30822f5-f881-493f-bf88-3d523b0e27a6" providerId="ADAL" clId="{9D62B88F-7099-4CD7-9F14-A4249C421CC5}" dt="2025-03-14T20:22:59.514" v="165" actId="1076"/>
          <ac:spMkLst>
            <pc:docMk/>
            <pc:sldMk cId="1435814156" sldId="259"/>
            <ac:spMk id="3" creationId="{28B8829F-35CA-2D20-9168-1FF4F982A6EE}"/>
          </ac:spMkLst>
        </pc:spChg>
        <pc:graphicFrameChg chg="add del mod">
          <ac:chgData name="Kaynak, Ahmet (kaynakat)" userId="e30822f5-f881-493f-bf88-3d523b0e27a6" providerId="ADAL" clId="{9D62B88F-7099-4CD7-9F14-A4249C421CC5}" dt="2025-03-17T17:34:40.059" v="218" actId="478"/>
          <ac:graphicFrameMkLst>
            <pc:docMk/>
            <pc:sldMk cId="1435814156" sldId="259"/>
            <ac:graphicFrameMk id="2" creationId="{C32E8B67-D4D8-0BAC-4B12-AF1F44BC376B}"/>
          </ac:graphicFrameMkLst>
        </pc:graphicFrameChg>
        <pc:graphicFrameChg chg="add mod modGraphic">
          <ac:chgData name="Kaynak, Ahmet (kaynakat)" userId="e30822f5-f881-493f-bf88-3d523b0e27a6" providerId="ADAL" clId="{9D62B88F-7099-4CD7-9F14-A4249C421CC5}" dt="2025-03-17T17:36:31.795" v="219" actId="1076"/>
          <ac:graphicFrameMkLst>
            <pc:docMk/>
            <pc:sldMk cId="1435814156" sldId="259"/>
            <ac:graphicFrameMk id="5" creationId="{3F469973-3D06-537E-456A-B2EBEE09428B}"/>
          </ac:graphicFrameMkLst>
        </pc:graphicFrameChg>
      </pc:sldChg>
    </pc:docChg>
  </pc:docChgLst>
  <pc:docChgLst>
    <pc:chgData name="Kaynak, Ahmet (kaynakat)" userId="e30822f5-f881-493f-bf88-3d523b0e27a6" providerId="ADAL" clId="{21921C31-7F3C-4C5E-ABCC-1F35672F3F5D}"/>
    <pc:docChg chg="undo custSel modSld">
      <pc:chgData name="Kaynak, Ahmet (kaynakat)" userId="e30822f5-f881-493f-bf88-3d523b0e27a6" providerId="ADAL" clId="{21921C31-7F3C-4C5E-ABCC-1F35672F3F5D}" dt="2025-02-13T15:28:15.612" v="6" actId="1076"/>
      <pc:docMkLst>
        <pc:docMk/>
      </pc:docMkLst>
      <pc:sldChg chg="addSp modSp mod">
        <pc:chgData name="Kaynak, Ahmet (kaynakat)" userId="e30822f5-f881-493f-bf88-3d523b0e27a6" providerId="ADAL" clId="{21921C31-7F3C-4C5E-ABCC-1F35672F3F5D}" dt="2025-02-13T15:28:15.612" v="6" actId="1076"/>
        <pc:sldMkLst>
          <pc:docMk/>
          <pc:sldMk cId="2110851604" sldId="258"/>
        </pc:sldMkLst>
        <pc:spChg chg="add mod">
          <ac:chgData name="Kaynak, Ahmet (kaynakat)" userId="e30822f5-f881-493f-bf88-3d523b0e27a6" providerId="ADAL" clId="{21921C31-7F3C-4C5E-ABCC-1F35672F3F5D}" dt="2025-02-13T15:28:15.612" v="6" actId="1076"/>
          <ac:spMkLst>
            <pc:docMk/>
            <pc:sldMk cId="2110851604" sldId="258"/>
            <ac:spMk id="3" creationId="{7422526D-8CE4-2DAB-7C5F-A4BAEF10F5DD}"/>
          </ac:spMkLst>
        </pc:spChg>
        <pc:cxnChg chg="mod">
          <ac:chgData name="Kaynak, Ahmet (kaynakat)" userId="e30822f5-f881-493f-bf88-3d523b0e27a6" providerId="ADAL" clId="{21921C31-7F3C-4C5E-ABCC-1F35672F3F5D}" dt="2025-02-13T15:28:02.520" v="1" actId="1076"/>
          <ac:cxnSpMkLst>
            <pc:docMk/>
            <pc:sldMk cId="2110851604" sldId="258"/>
            <ac:cxnSpMk id="7" creationId="{A9F63E21-DB90-4E68-BC9B-D8A4E0960784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FA88E4-34A6-4C0A-B252-B64162DD8B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F660C95-1BAC-4FA4-9904-C57B3C3E6F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006B1E-9B54-495F-800A-1A9B52C88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17BE8-C173-415D-9A97-B52F1E266DBC}" type="datetimeFigureOut">
              <a:rPr lang="en-US" smtClean="0"/>
              <a:t>3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4DBF0B-E872-4715-BB50-6CEFFA75D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F3ED83-4BA0-41A6-B1B6-8703F889E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24E33-A321-45F5-86F9-EE754BFE2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741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8AE7CF-E1EE-42BC-AB1C-E8DACDFF54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B5EB9F-7DFF-4E15-A8D6-430FB577D0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74C743-0500-41B7-B068-BABEA418F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17BE8-C173-415D-9A97-B52F1E266DBC}" type="datetimeFigureOut">
              <a:rPr lang="en-US" smtClean="0"/>
              <a:t>3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530330-E33E-4477-AA43-E0172391E4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AF95D1-C4AC-4050-98C4-7BC6C8EE7C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24E33-A321-45F5-86F9-EE754BFE2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608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A6CBB27-E795-44E5-92AA-243D6EEF9B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168BE5-BB02-4B9F-874A-83B43F6E25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7DEC10-A1BA-49E1-B22F-A27CA2313C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17BE8-C173-415D-9A97-B52F1E266DBC}" type="datetimeFigureOut">
              <a:rPr lang="en-US" smtClean="0"/>
              <a:t>3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23B28F-183F-4482-8A9C-3D28AE49C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4C7446-D6C8-4E7F-8A61-CCE31F4B3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24E33-A321-45F5-86F9-EE754BFE2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98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A164D9-E021-447C-B0E7-C530F7840A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0015B3-7B5F-48CF-8876-3629988FC1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3BFC9F-A1E0-4FE1-9FEC-F745F719B7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17BE8-C173-415D-9A97-B52F1E266DBC}" type="datetimeFigureOut">
              <a:rPr lang="en-US" smtClean="0"/>
              <a:t>3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70A715-DEC0-46EF-92A1-11791ABF1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999DA7-EE29-4193-92B6-0332DA8342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24E33-A321-45F5-86F9-EE754BFE2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1253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C58AA7-2CF1-4A05-9D87-CB11248197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AC37B5-8158-433D-A256-4F245F5DC5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0EE111-469D-4423-AB20-3A30A4851F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17BE8-C173-415D-9A97-B52F1E266DBC}" type="datetimeFigureOut">
              <a:rPr lang="en-US" smtClean="0"/>
              <a:t>3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60C585-0EE6-49AC-A2DF-6CB719BDA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A841BF-AE5A-4D86-9E44-4A660B08D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24E33-A321-45F5-86F9-EE754BFE2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306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0763F7-4786-4EE0-8807-7FA95C73E1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1107CD-D8F4-402B-8546-C4DD602F186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6EBD6E-3366-497C-A445-4F5158D041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10A8FC-252D-4E62-B690-706B0BA66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17BE8-C173-415D-9A97-B52F1E266DBC}" type="datetimeFigureOut">
              <a:rPr lang="en-US" smtClean="0"/>
              <a:t>3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5B7CC3-F698-4597-8C2F-668F06F33D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7C6E2C-F961-46CA-AA10-9CD0BD4CB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24E33-A321-45F5-86F9-EE754BFE2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2003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2846E4-D89B-45F8-BBB7-01481FCBDF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24C333-E3C3-4162-8490-DFB973BC6C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F076F5-C021-4718-A8B0-BF823CDF57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195AAB1-E5E8-4178-B1E1-B298BD70A4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C0807AC-ED6E-4402-A0E7-1C64CA3306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1A9E3E-BC47-40C6-9BF6-4EDE7BFA6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17BE8-C173-415D-9A97-B52F1E266DBC}" type="datetimeFigureOut">
              <a:rPr lang="en-US" smtClean="0"/>
              <a:t>3/1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44F0EF6-F933-4DFF-A722-33CAFB616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9AC152-2753-4F64-8B19-F4317F6E3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24E33-A321-45F5-86F9-EE754BFE2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7704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98E6E9-A2DA-447F-B2DD-3A1FDA2889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7559F4-3324-4480-B0B4-4141A808C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17BE8-C173-415D-9A97-B52F1E266DBC}" type="datetimeFigureOut">
              <a:rPr lang="en-US" smtClean="0"/>
              <a:t>3/1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461B5C-2248-46FA-AC1D-47B1AA59BF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AC912E3-5C3F-45E9-A005-D13F5B1C0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24E33-A321-45F5-86F9-EE754BFE2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099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642B9E7-E666-41F4-A67E-74271043C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17BE8-C173-415D-9A97-B52F1E266DBC}" type="datetimeFigureOut">
              <a:rPr lang="en-US" smtClean="0"/>
              <a:t>3/1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BA694CB-F57B-46B5-A332-07266AACA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B37DD0-AAC8-407B-8234-3F353A6173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24E33-A321-45F5-86F9-EE754BFE2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375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A13980-9AE8-4E87-9065-537D6142E5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842BCF-1160-4595-80C6-C8DF8B9149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EEA3E9-A657-42DD-8CB9-0D2D2980C3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E3B259-2D3F-429A-BE9A-585FC9FBD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17BE8-C173-415D-9A97-B52F1E266DBC}" type="datetimeFigureOut">
              <a:rPr lang="en-US" smtClean="0"/>
              <a:t>3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59E1AF-6DA4-4555-913C-A025D451BF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2B7252-63DE-4B9F-AFF3-26F9F3455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24E33-A321-45F5-86F9-EE754BFE2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487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FF1B1D-3170-4E52-B8D3-0526E950DE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7432B62-D839-44E7-B89D-ED310AFF48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E1D210-C3BC-439F-BBD5-9A2C0C5CD6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69D214-18D1-451A-B12A-26F1A1C77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17BE8-C173-415D-9A97-B52F1E266DBC}" type="datetimeFigureOut">
              <a:rPr lang="en-US" smtClean="0"/>
              <a:t>3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DCEA53-AA5F-43C7-B9E6-848F0A999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96EE64-0421-4D5F-AE44-C46FF18A2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24E33-A321-45F5-86F9-EE754BFE2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967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3D91A80-51FF-4076-B753-1D6A9BEB66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981AF6-CEBD-4202-8681-64AE986F0D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8816DC-ADC8-4549-B161-88F06475BD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217BE8-C173-415D-9A97-B52F1E266DBC}" type="datetimeFigureOut">
              <a:rPr lang="en-US" smtClean="0"/>
              <a:t>3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CD1330-151C-4922-AB5C-F1A4D52767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E98303-E08C-40B5-8429-2D76B1FA6E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924E33-A321-45F5-86F9-EE754BFE2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628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72CBA85-DADE-E5CB-E7DD-04FBFA23630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8B8829F-35CA-2D20-9168-1FF4F982A6EE}"/>
              </a:ext>
            </a:extLst>
          </p:cNvPr>
          <p:cNvSpPr txBox="1"/>
          <p:nvPr/>
        </p:nvSpPr>
        <p:spPr>
          <a:xfrm>
            <a:off x="1927563" y="465818"/>
            <a:ext cx="8406490" cy="4087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1. Particle size distribution of the synthesized nanoparticles measured by DL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3F469973-3D06-537E-456A-B2EBEE0942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71655286"/>
              </p:ext>
            </p:extLst>
          </p:nvPr>
        </p:nvGraphicFramePr>
        <p:xfrm>
          <a:off x="2224751" y="1147838"/>
          <a:ext cx="6096000" cy="2852737"/>
        </p:xfrm>
        <a:graphic>
          <a:graphicData uri="http://schemas.openxmlformats.org/drawingml/2006/table">
            <a:tbl>
              <a:tblPr firstRow="1" bandRow="1">
                <a:tableStyleId>{0505E3EF-67EA-436B-97B2-0124C06EBD24}</a:tableStyleId>
              </a:tblPr>
              <a:tblGrid>
                <a:gridCol w="2032000">
                  <a:extLst>
                    <a:ext uri="{9D8B030D-6E8A-4147-A177-3AD203B41FA5}">
                      <a16:colId xmlns:a16="http://schemas.microsoft.com/office/drawing/2014/main" val="4115728144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2552357178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424983454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Lipid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/>
                        <a:t>Average Particle Size (nm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Zeta Potential (mV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1502253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DOP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258±42.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-10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250358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err="1"/>
                        <a:t>SapC</a:t>
                      </a:r>
                      <a:r>
                        <a:rPr lang="en-US" sz="1600" dirty="0"/>
                        <a:t>-DOP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16±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-7.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95849163"/>
                  </a:ext>
                </a:extLst>
              </a:tr>
              <a:tr h="419417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DOP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89±15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-14.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671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DSP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29±6.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-0.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6263568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DSP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242±81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.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07008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/>
                        <a:t>DOP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205±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-6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5651133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358141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CDDC5F2-36E1-4392-B00A-8BDC90ADF21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2834776"/>
              </p:ext>
            </p:extLst>
          </p:nvPr>
        </p:nvGraphicFramePr>
        <p:xfrm>
          <a:off x="175394" y="552260"/>
          <a:ext cx="11659342" cy="505183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856300">
                  <a:extLst>
                    <a:ext uri="{9D8B030D-6E8A-4147-A177-3AD203B41FA5}">
                      <a16:colId xmlns:a16="http://schemas.microsoft.com/office/drawing/2014/main" val="1383286499"/>
                    </a:ext>
                  </a:extLst>
                </a:gridCol>
                <a:gridCol w="568431">
                  <a:extLst>
                    <a:ext uri="{9D8B030D-6E8A-4147-A177-3AD203B41FA5}">
                      <a16:colId xmlns:a16="http://schemas.microsoft.com/office/drawing/2014/main" val="971729182"/>
                    </a:ext>
                  </a:extLst>
                </a:gridCol>
                <a:gridCol w="625581">
                  <a:extLst>
                    <a:ext uri="{9D8B030D-6E8A-4147-A177-3AD203B41FA5}">
                      <a16:colId xmlns:a16="http://schemas.microsoft.com/office/drawing/2014/main" val="1154020627"/>
                    </a:ext>
                  </a:extLst>
                </a:gridCol>
                <a:gridCol w="625581">
                  <a:extLst>
                    <a:ext uri="{9D8B030D-6E8A-4147-A177-3AD203B41FA5}">
                      <a16:colId xmlns:a16="http://schemas.microsoft.com/office/drawing/2014/main" val="2691239280"/>
                    </a:ext>
                  </a:extLst>
                </a:gridCol>
                <a:gridCol w="562081">
                  <a:extLst>
                    <a:ext uri="{9D8B030D-6E8A-4147-A177-3AD203B41FA5}">
                      <a16:colId xmlns:a16="http://schemas.microsoft.com/office/drawing/2014/main" val="1135744774"/>
                    </a:ext>
                  </a:extLst>
                </a:gridCol>
                <a:gridCol w="562081">
                  <a:extLst>
                    <a:ext uri="{9D8B030D-6E8A-4147-A177-3AD203B41FA5}">
                      <a16:colId xmlns:a16="http://schemas.microsoft.com/office/drawing/2014/main" val="1797973505"/>
                    </a:ext>
                  </a:extLst>
                </a:gridCol>
                <a:gridCol w="562081">
                  <a:extLst>
                    <a:ext uri="{9D8B030D-6E8A-4147-A177-3AD203B41FA5}">
                      <a16:colId xmlns:a16="http://schemas.microsoft.com/office/drawing/2014/main" val="1728705512"/>
                    </a:ext>
                  </a:extLst>
                </a:gridCol>
                <a:gridCol w="562081">
                  <a:extLst>
                    <a:ext uri="{9D8B030D-6E8A-4147-A177-3AD203B41FA5}">
                      <a16:colId xmlns:a16="http://schemas.microsoft.com/office/drawing/2014/main" val="4291173546"/>
                    </a:ext>
                  </a:extLst>
                </a:gridCol>
                <a:gridCol w="562081">
                  <a:extLst>
                    <a:ext uri="{9D8B030D-6E8A-4147-A177-3AD203B41FA5}">
                      <a16:colId xmlns:a16="http://schemas.microsoft.com/office/drawing/2014/main" val="35465706"/>
                    </a:ext>
                  </a:extLst>
                </a:gridCol>
                <a:gridCol w="631931">
                  <a:extLst>
                    <a:ext uri="{9D8B030D-6E8A-4147-A177-3AD203B41FA5}">
                      <a16:colId xmlns:a16="http://schemas.microsoft.com/office/drawing/2014/main" val="1655413777"/>
                    </a:ext>
                  </a:extLst>
                </a:gridCol>
                <a:gridCol w="484294">
                  <a:extLst>
                    <a:ext uri="{9D8B030D-6E8A-4147-A177-3AD203B41FA5}">
                      <a16:colId xmlns:a16="http://schemas.microsoft.com/office/drawing/2014/main" val="102441921"/>
                    </a:ext>
                  </a:extLst>
                </a:gridCol>
                <a:gridCol w="562081">
                  <a:extLst>
                    <a:ext uri="{9D8B030D-6E8A-4147-A177-3AD203B41FA5}">
                      <a16:colId xmlns:a16="http://schemas.microsoft.com/office/drawing/2014/main" val="539513580"/>
                    </a:ext>
                  </a:extLst>
                </a:gridCol>
                <a:gridCol w="562081">
                  <a:extLst>
                    <a:ext uri="{9D8B030D-6E8A-4147-A177-3AD203B41FA5}">
                      <a16:colId xmlns:a16="http://schemas.microsoft.com/office/drawing/2014/main" val="1072108456"/>
                    </a:ext>
                  </a:extLst>
                </a:gridCol>
                <a:gridCol w="562081">
                  <a:extLst>
                    <a:ext uri="{9D8B030D-6E8A-4147-A177-3AD203B41FA5}">
                      <a16:colId xmlns:a16="http://schemas.microsoft.com/office/drawing/2014/main" val="1252518474"/>
                    </a:ext>
                  </a:extLst>
                </a:gridCol>
                <a:gridCol w="562081">
                  <a:extLst>
                    <a:ext uri="{9D8B030D-6E8A-4147-A177-3AD203B41FA5}">
                      <a16:colId xmlns:a16="http://schemas.microsoft.com/office/drawing/2014/main" val="3200554863"/>
                    </a:ext>
                  </a:extLst>
                </a:gridCol>
                <a:gridCol w="533509">
                  <a:extLst>
                    <a:ext uri="{9D8B030D-6E8A-4147-A177-3AD203B41FA5}">
                      <a16:colId xmlns:a16="http://schemas.microsoft.com/office/drawing/2014/main" val="2846000569"/>
                    </a:ext>
                  </a:extLst>
                </a:gridCol>
                <a:gridCol w="672768">
                  <a:extLst>
                    <a:ext uri="{9D8B030D-6E8A-4147-A177-3AD203B41FA5}">
                      <a16:colId xmlns:a16="http://schemas.microsoft.com/office/drawing/2014/main" val="1058877698"/>
                    </a:ext>
                  </a:extLst>
                </a:gridCol>
                <a:gridCol w="403319">
                  <a:extLst>
                    <a:ext uri="{9D8B030D-6E8A-4147-A177-3AD203B41FA5}">
                      <a16:colId xmlns:a16="http://schemas.microsoft.com/office/drawing/2014/main" val="3783458140"/>
                    </a:ext>
                  </a:extLst>
                </a:gridCol>
                <a:gridCol w="740037">
                  <a:extLst>
                    <a:ext uri="{9D8B030D-6E8A-4147-A177-3AD203B41FA5}">
                      <a16:colId xmlns:a16="http://schemas.microsoft.com/office/drawing/2014/main" val="2175493477"/>
                    </a:ext>
                  </a:extLst>
                </a:gridCol>
                <a:gridCol w="458862">
                  <a:extLst>
                    <a:ext uri="{9D8B030D-6E8A-4147-A177-3AD203B41FA5}">
                      <a16:colId xmlns:a16="http://schemas.microsoft.com/office/drawing/2014/main" val="291715069"/>
                    </a:ext>
                  </a:extLst>
                </a:gridCol>
              </a:tblGrid>
              <a:tr h="2962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Group No.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WBC 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×10</a:t>
                      </a:r>
                      <a:r>
                        <a:rPr lang="en-US" sz="800" b="1" u="none" strike="noStrike" baseline="30000" dirty="0">
                          <a:effectLst/>
                          <a:latin typeface="+mn-lt"/>
                        </a:rPr>
                        <a:t>3 </a:t>
                      </a: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/µL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RBC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×10</a:t>
                      </a:r>
                      <a:r>
                        <a:rPr lang="en-US" sz="800" b="1" u="none" strike="noStrike" baseline="30000" dirty="0">
                          <a:effectLst/>
                          <a:latin typeface="+mn-lt"/>
                        </a:rPr>
                        <a:t>6 </a:t>
                      </a: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/µL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HGB 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g/dL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HCT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 (%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MCV 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</a:t>
                      </a:r>
                      <a:r>
                        <a:rPr lang="en-US" sz="800" b="1" u="none" strike="noStrike" dirty="0" err="1">
                          <a:effectLst/>
                          <a:latin typeface="+mn-lt"/>
                        </a:rPr>
                        <a:t>fL</a:t>
                      </a: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MCH 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</a:t>
                      </a:r>
                      <a:r>
                        <a:rPr lang="en-US" sz="800" b="1" u="none" strike="noStrike" dirty="0" err="1">
                          <a:effectLst/>
                          <a:latin typeface="+mn-lt"/>
                        </a:rPr>
                        <a:t>pg</a:t>
                      </a: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MCHC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 (g/dL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PLT 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×10</a:t>
                      </a:r>
                      <a:r>
                        <a:rPr lang="en-US" sz="800" b="1" u="none" strike="noStrike" baseline="30000" dirty="0">
                          <a:effectLst/>
                          <a:latin typeface="+mn-lt"/>
                        </a:rPr>
                        <a:t>3</a:t>
                      </a: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 /</a:t>
                      </a:r>
                      <a:r>
                        <a:rPr lang="el-GR" sz="800" b="1" u="none" strike="noStrike" dirty="0">
                          <a:effectLst/>
                          <a:latin typeface="+mn-lt"/>
                        </a:rPr>
                        <a:t>μ</a:t>
                      </a: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L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err="1">
                          <a:effectLst/>
                          <a:latin typeface="+mn-lt"/>
                        </a:rPr>
                        <a:t>Abs_Neuts</a:t>
                      </a:r>
                      <a:endParaRPr lang="en-US" sz="800" b="1" u="none" strike="noStrike" dirty="0">
                        <a:effectLst/>
                        <a:latin typeface="+mn-lt"/>
                      </a:endParaRP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×10</a:t>
                      </a:r>
                      <a:r>
                        <a:rPr lang="en-US" sz="800" b="1" u="none" strike="noStrike" baseline="30000" dirty="0">
                          <a:effectLst/>
                          <a:latin typeface="+mn-lt"/>
                        </a:rPr>
                        <a:t>3 </a:t>
                      </a: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/µL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err="1">
                          <a:effectLst/>
                          <a:latin typeface="+mn-lt"/>
                        </a:rPr>
                        <a:t>Neuts</a:t>
                      </a:r>
                      <a:endParaRPr lang="en-US" sz="800" b="1" u="none" strike="noStrike" dirty="0">
                        <a:effectLst/>
                        <a:latin typeface="+mn-lt"/>
                      </a:endParaRP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%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err="1">
                          <a:effectLst/>
                          <a:latin typeface="+mn-lt"/>
                        </a:rPr>
                        <a:t>Abs_lym</a:t>
                      </a:r>
                      <a:endParaRPr lang="en-US" sz="800" b="1" u="none" strike="noStrike" dirty="0">
                        <a:effectLst/>
                        <a:latin typeface="+mn-lt"/>
                      </a:endParaRP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×10</a:t>
                      </a:r>
                      <a:r>
                        <a:rPr lang="en-US" sz="800" b="1" u="none" strike="noStrike" baseline="30000" dirty="0">
                          <a:effectLst/>
                          <a:latin typeface="+mn-lt"/>
                        </a:rPr>
                        <a:t>3 </a:t>
                      </a: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/µL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err="1">
                          <a:effectLst/>
                          <a:latin typeface="+mn-lt"/>
                        </a:rPr>
                        <a:t>Lym</a:t>
                      </a: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 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%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err="1">
                          <a:effectLst/>
                          <a:latin typeface="+mn-lt"/>
                        </a:rPr>
                        <a:t>Abs_mono</a:t>
                      </a:r>
                      <a:endParaRPr lang="en-US" sz="800" b="1" u="none" strike="noStrike" dirty="0">
                        <a:effectLst/>
                        <a:latin typeface="+mn-lt"/>
                      </a:endParaRP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×10</a:t>
                      </a:r>
                      <a:r>
                        <a:rPr lang="en-US" sz="800" b="1" u="none" strike="noStrike" baseline="30000" dirty="0">
                          <a:effectLst/>
                          <a:latin typeface="+mn-lt"/>
                        </a:rPr>
                        <a:t>3 </a:t>
                      </a: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/µL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Mono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%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err="1">
                          <a:effectLst/>
                          <a:latin typeface="+mn-lt"/>
                        </a:rPr>
                        <a:t>Abs_eos</a:t>
                      </a:r>
                      <a:endParaRPr lang="en-US" sz="800" b="1" u="none" strike="noStrike" dirty="0">
                        <a:effectLst/>
                        <a:latin typeface="+mn-lt"/>
                      </a:endParaRP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×10</a:t>
                      </a:r>
                      <a:r>
                        <a:rPr lang="en-US" sz="800" b="1" u="none" strike="noStrike" baseline="30000" dirty="0">
                          <a:effectLst/>
                          <a:latin typeface="+mn-lt"/>
                        </a:rPr>
                        <a:t>3 </a:t>
                      </a: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/µL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Eos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 (%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err="1">
                          <a:effectLst/>
                          <a:latin typeface="+mn-lt"/>
                        </a:rPr>
                        <a:t>Abs_basos</a:t>
                      </a:r>
                      <a:endParaRPr lang="en-US" sz="800" b="1" u="none" strike="noStrike" dirty="0">
                        <a:effectLst/>
                        <a:latin typeface="+mn-lt"/>
                      </a:endParaRP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×10</a:t>
                      </a:r>
                      <a:r>
                        <a:rPr lang="en-US" sz="800" b="1" u="none" strike="noStrike" baseline="30000" dirty="0">
                          <a:effectLst/>
                          <a:latin typeface="+mn-lt"/>
                        </a:rPr>
                        <a:t>3 </a:t>
                      </a: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/µL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err="1">
                          <a:effectLst/>
                          <a:latin typeface="+mn-lt"/>
                        </a:rPr>
                        <a:t>Basos</a:t>
                      </a: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 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(%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extLst>
                  <a:ext uri="{0D108BD9-81ED-4DB2-BD59-A6C34878D82A}">
                    <a16:rowId xmlns:a16="http://schemas.microsoft.com/office/drawing/2014/main" val="3028019647"/>
                  </a:ext>
                </a:extLst>
              </a:tr>
              <a:tr h="209316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Control/ Male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 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.8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3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.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4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6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3.7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7.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7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5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5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70460865"/>
                  </a:ext>
                </a:extLst>
              </a:tr>
              <a:tr h="209316">
                <a:tc vMerge="1"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6.4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9.1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9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2.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6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8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4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.3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21.1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.7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74.1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2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.9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0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4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0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extLst>
                  <a:ext uri="{0D108BD9-81ED-4DB2-BD59-A6C34878D82A}">
                    <a16:rowId xmlns:a16="http://schemas.microsoft.com/office/drawing/2014/main" val="334563765"/>
                  </a:ext>
                </a:extLst>
              </a:tr>
              <a:tr h="209316">
                <a:tc vMerge="1"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3.7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9.4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4.3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0.5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3.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5.2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5.3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8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.3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24.1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9.3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68.5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5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.6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3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2.5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.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extLst>
                  <a:ext uri="{0D108BD9-81ED-4DB2-BD59-A6C34878D82A}">
                    <a16:rowId xmlns:a16="http://schemas.microsoft.com/office/drawing/2014/main" val="2815217513"/>
                  </a:ext>
                </a:extLst>
              </a:tr>
              <a:tr h="296254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Control/Female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 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8.8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0.5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5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44.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42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4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34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69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.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6.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75.6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4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5.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0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extLst>
                  <a:ext uri="{0D108BD9-81ED-4DB2-BD59-A6C34878D82A}">
                    <a16:rowId xmlns:a16="http://schemas.microsoft.com/office/drawing/2014/main" val="3434650975"/>
                  </a:ext>
                </a:extLst>
              </a:tr>
              <a:tr h="209316">
                <a:tc vMerge="1"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3.3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9.9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5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3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3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5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5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5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3.9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29.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7.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55.6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.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7.6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6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5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2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2.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extLst>
                  <a:ext uri="{0D108BD9-81ED-4DB2-BD59-A6C34878D82A}">
                    <a16:rowId xmlns:a16="http://schemas.microsoft.com/office/drawing/2014/main" val="989802984"/>
                  </a:ext>
                </a:extLst>
              </a:tr>
              <a:tr h="209316">
                <a:tc vMerge="1"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6.0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0.5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44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5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6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57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.2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26.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9.9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62.1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9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5.6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6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3.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2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.4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extLst>
                  <a:ext uri="{0D108BD9-81ED-4DB2-BD59-A6C34878D82A}">
                    <a16:rowId xmlns:a16="http://schemas.microsoft.com/office/drawing/2014/main" val="2897513988"/>
                  </a:ext>
                </a:extLst>
              </a:tr>
              <a:tr h="2962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Mea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.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.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.8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1.7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2.8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.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5.6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2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6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.7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5.6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4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0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30982101"/>
                  </a:ext>
                </a:extLst>
              </a:tr>
              <a:tr h="2962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S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6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4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5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9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4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7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7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7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55402838"/>
                  </a:ext>
                </a:extLst>
              </a:tr>
              <a:tr h="20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Change(fold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31231704"/>
                  </a:ext>
                </a:extLst>
              </a:tr>
              <a:tr h="442446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  <a:latin typeface="+mn-lt"/>
                        </a:rPr>
                        <a:t>SapC-DOPG/Male</a:t>
                      </a:r>
                    </a:p>
                    <a:p>
                      <a:pPr algn="ctr" fontAlgn="b"/>
                      <a:r>
                        <a:rPr lang="it-IT" sz="800" b="1" u="none" strike="noStrike" dirty="0">
                          <a:effectLst/>
                          <a:latin typeface="+mn-lt"/>
                        </a:rPr>
                        <a:t>SapC (34 mg/kg)</a:t>
                      </a:r>
                    </a:p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OPG (21.4 mg/kg)</a:t>
                      </a: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9.0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8.1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1.7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3.2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0.6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4.3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5.2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1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.5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7.3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6.8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76.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4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4.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.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0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4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extLst>
                  <a:ext uri="{0D108BD9-81ED-4DB2-BD59-A6C34878D82A}">
                    <a16:rowId xmlns:a16="http://schemas.microsoft.com/office/drawing/2014/main" val="3525778336"/>
                  </a:ext>
                </a:extLst>
              </a:tr>
              <a:tr h="20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6.9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0.1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3.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39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8.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3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34.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7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4.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24.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0.7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63.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.2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7.1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6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.5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3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2.0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extLst>
                  <a:ext uri="{0D108BD9-81ED-4DB2-BD59-A6C34878D82A}">
                    <a16:rowId xmlns:a16="http://schemas.microsoft.com/office/drawing/2014/main" val="934388587"/>
                  </a:ext>
                </a:extLst>
              </a:tr>
              <a:tr h="20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1.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0.1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3.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0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9.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3.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4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98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2.2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9.1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8.7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74.6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7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6.0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0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0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0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0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extLst>
                  <a:ext uri="{0D108BD9-81ED-4DB2-BD59-A6C34878D82A}">
                    <a16:rowId xmlns:a16="http://schemas.microsoft.com/office/drawing/2014/main" val="2451858141"/>
                  </a:ext>
                </a:extLst>
              </a:tr>
              <a:tr h="4424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err="1">
                          <a:effectLst/>
                          <a:latin typeface="+mn-lt"/>
                        </a:rPr>
                        <a:t>SapC</a:t>
                      </a: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-DOPG/Female</a:t>
                      </a: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it-IT" sz="800" b="1" u="none" strike="noStrike" dirty="0">
                          <a:effectLst/>
                          <a:latin typeface="+mn-lt"/>
                        </a:rPr>
                        <a:t>SapC (34 mg/kg)</a:t>
                      </a:r>
                    </a:p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OPG (21.4 mg/k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.3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6.3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9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26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41.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3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6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0.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3.6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84.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4.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0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6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extLst>
                  <a:ext uri="{0D108BD9-81ED-4DB2-BD59-A6C34878D82A}">
                    <a16:rowId xmlns:a16="http://schemas.microsoft.com/office/drawing/2014/main" val="3759367403"/>
                  </a:ext>
                </a:extLst>
              </a:tr>
              <a:tr h="20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1.1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9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3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37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40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4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35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3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.6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14.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9.0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81.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3.4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0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4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0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0.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extLst>
                  <a:ext uri="{0D108BD9-81ED-4DB2-BD59-A6C34878D82A}">
                    <a16:rowId xmlns:a16="http://schemas.microsoft.com/office/drawing/2014/main" val="44018281"/>
                  </a:ext>
                </a:extLst>
              </a:tr>
              <a:tr h="20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5.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8.6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1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37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43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0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3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4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7.9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5.1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86.1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3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5.3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0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5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0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1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extLst>
                  <a:ext uri="{0D108BD9-81ED-4DB2-BD59-A6C34878D82A}">
                    <a16:rowId xmlns:a16="http://schemas.microsoft.com/office/drawing/2014/main" val="910144245"/>
                  </a:ext>
                </a:extLst>
              </a:tr>
              <a:tr h="2962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Mea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9.8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8.7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2.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5.6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5.0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1.9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29.2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64.4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.7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5.6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7.3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77.6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5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5.3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1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.0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0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5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extLst>
                  <a:ext uri="{0D108BD9-81ED-4DB2-BD59-A6C34878D82A}">
                    <a16:rowId xmlns:a16="http://schemas.microsoft.com/office/drawing/2014/main" val="2364998579"/>
                  </a:ext>
                </a:extLst>
              </a:tr>
              <a:tr h="2962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S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.1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2.9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.1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2.8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3.9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.5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1.6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39.5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.2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5.3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2.4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7.6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3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.1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2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.1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1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</a:rPr>
                        <a:t>0.7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extLst>
                  <a:ext uri="{0D108BD9-81ED-4DB2-BD59-A6C34878D82A}">
                    <a16:rowId xmlns:a16="http://schemas.microsoft.com/office/drawing/2014/main" val="913860469"/>
                  </a:ext>
                </a:extLst>
              </a:tr>
              <a:tr h="2962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Change(fold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8" marR="3228" marT="322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8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6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0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4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6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4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56118091"/>
                  </a:ext>
                </a:extLst>
              </a:tr>
            </a:tbl>
          </a:graphicData>
        </a:graphic>
      </p:graphicFrame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CFD11D1B-16FA-4C51-8C46-1AFCA5961D95}"/>
              </a:ext>
            </a:extLst>
          </p:cNvPr>
          <p:cNvCxnSpPr/>
          <p:nvPr/>
        </p:nvCxnSpPr>
        <p:spPr>
          <a:xfrm>
            <a:off x="91440" y="866775"/>
            <a:ext cx="115538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A9F63E21-DB90-4E68-BC9B-D8A4E0960784}"/>
              </a:ext>
            </a:extLst>
          </p:cNvPr>
          <p:cNvCxnSpPr/>
          <p:nvPr/>
        </p:nvCxnSpPr>
        <p:spPr>
          <a:xfrm>
            <a:off x="91440" y="552260"/>
            <a:ext cx="115538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7E728451-D064-4FD6-A5BA-B067B8D122FA}"/>
              </a:ext>
            </a:extLst>
          </p:cNvPr>
          <p:cNvCxnSpPr/>
          <p:nvPr/>
        </p:nvCxnSpPr>
        <p:spPr>
          <a:xfrm>
            <a:off x="91440" y="5673940"/>
            <a:ext cx="115538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7422526D-8CE4-2DAB-7C5F-A4BAEF10F5DD}"/>
              </a:ext>
            </a:extLst>
          </p:cNvPr>
          <p:cNvSpPr txBox="1"/>
          <p:nvPr/>
        </p:nvSpPr>
        <p:spPr>
          <a:xfrm>
            <a:off x="91440" y="108569"/>
            <a:ext cx="8406490" cy="4087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2. Hematological analysis of mice injected with </a:t>
            </a:r>
            <a:r>
              <a:rPr lang="en-US" sz="12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pC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DOPG LV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0851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1</TotalTime>
  <Words>561</Words>
  <Application>Microsoft Office PowerPoint</Application>
  <PresentationFormat>Widescreen</PresentationFormat>
  <Paragraphs>42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met</dc:creator>
  <cp:lastModifiedBy>Kaynak, Ahmet (kaynakat)</cp:lastModifiedBy>
  <cp:revision>9</cp:revision>
  <dcterms:created xsi:type="dcterms:W3CDTF">2021-07-20T14:22:55Z</dcterms:created>
  <dcterms:modified xsi:type="dcterms:W3CDTF">2025-03-17T17:36:41Z</dcterms:modified>
</cp:coreProperties>
</file>